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56" r:id="rId3"/>
    <p:sldId id="259" r:id="rId4"/>
    <p:sldId id="257" r:id="rId5"/>
    <p:sldId id="261" r:id="rId6"/>
    <p:sldId id="263" r:id="rId7"/>
    <p:sldId id="262" r:id="rId8"/>
    <p:sldId id="265" r:id="rId9"/>
    <p:sldId id="266" r:id="rId10"/>
    <p:sldId id="260" r:id="rId11"/>
    <p:sldId id="264" r:id="rId12"/>
    <p:sldId id="258" r:id="rId1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128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9012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252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266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34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753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950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931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13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9687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5841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544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C0C11-B8AB-4F90-917D-C244A9E34ADB}" type="datetimeFigureOut">
              <a:rPr lang="en-GB" smtClean="0"/>
              <a:t>26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3C87D-AE0E-429D-BF6B-A90977FE1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385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BD66A-3C69-41D4-A321-DDB29DA9E80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osterior Predictive Checks</a:t>
            </a:r>
            <a:endParaRPr lang="en-GB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B34DBB-5BBB-453E-A290-48431505666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sz="2000" dirty="0"/>
              <a:t>In each graph, y denotes the observed values and </a:t>
            </a:r>
            <a:r>
              <a:rPr lang="en-US" sz="2000" dirty="0" err="1"/>
              <a:t>yrep</a:t>
            </a:r>
            <a:r>
              <a:rPr lang="en-US" sz="2000" dirty="0"/>
              <a:t> denotes draws from the posterior predictive distribution. 10 draws were used in each figure, 2 from each of the 5 imputed sub-datasets. Where applicable, dots represent the mean and lines represent the interval containing 95% of the probability mass.  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23331082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693695B7-D0C7-4241-A9D1-FFF01437970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81155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1148329D-92D8-4A95-A110-C085293F230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27722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scatter chart&#10;&#10;Description automatically generated">
            <a:extLst>
              <a:ext uri="{FF2B5EF4-FFF2-40B4-BE49-F238E27FC236}">
                <a16:creationId xmlns:a16="http://schemas.microsoft.com/office/drawing/2014/main" id="{608897CC-D9D2-4F35-9756-C4AD24E03DF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6650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60F39E5D-AAE5-4BDE-A03D-2FCD6A892E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31247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7AB1D209-E258-4C56-AFC7-092AE39DA8E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5788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scatter chart&#10;&#10;Description automatically generated">
            <a:extLst>
              <a:ext uri="{FF2B5EF4-FFF2-40B4-BE49-F238E27FC236}">
                <a16:creationId xmlns:a16="http://schemas.microsoft.com/office/drawing/2014/main" id="{FE85D672-4AAC-4AB7-805C-4BFC7557770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642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scatter chart&#10;&#10;Description automatically generated">
            <a:extLst>
              <a:ext uri="{FF2B5EF4-FFF2-40B4-BE49-F238E27FC236}">
                <a16:creationId xmlns:a16="http://schemas.microsoft.com/office/drawing/2014/main" id="{BDEBB2B7-4713-4607-AC81-E4A8887643C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30365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8180CD20-DF52-45D3-98DE-5EB78C88EE1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26570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histogram&#10;&#10;Description automatically generated">
            <a:extLst>
              <a:ext uri="{FF2B5EF4-FFF2-40B4-BE49-F238E27FC236}">
                <a16:creationId xmlns:a16="http://schemas.microsoft.com/office/drawing/2014/main" id="{DFF57ED5-4CB4-4C3E-86A4-9CA9C4FF82B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56582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scatter chart&#10;&#10;Description automatically generated">
            <a:extLst>
              <a:ext uri="{FF2B5EF4-FFF2-40B4-BE49-F238E27FC236}">
                <a16:creationId xmlns:a16="http://schemas.microsoft.com/office/drawing/2014/main" id="{B4902BE0-8382-4EF2-8F7C-B18D784C5BD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70126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Chart, scatter chart&#10;&#10;Description automatically generated">
            <a:extLst>
              <a:ext uri="{FF2B5EF4-FFF2-40B4-BE49-F238E27FC236}">
                <a16:creationId xmlns:a16="http://schemas.microsoft.com/office/drawing/2014/main" id="{7E2AC65C-EE67-48E6-ADA5-F5FAFC5C865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" y="770887"/>
            <a:ext cx="8178799" cy="5316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2406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59</Words>
  <Application>Microsoft Office PowerPoint</Application>
  <PresentationFormat>On-screen Show (4:3)</PresentationFormat>
  <Paragraphs>2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sterior Predictive Check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sterior Predictive Checks</dc:title>
  <dc:creator>Nol Swaddiwudhipong</dc:creator>
  <cp:lastModifiedBy>Nol Swaddiwudhipong</cp:lastModifiedBy>
  <cp:revision>1</cp:revision>
  <dcterms:created xsi:type="dcterms:W3CDTF">2022-03-26T22:23:42Z</dcterms:created>
  <dcterms:modified xsi:type="dcterms:W3CDTF">2022-03-26T23:01:02Z</dcterms:modified>
</cp:coreProperties>
</file>